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D1E60E-E0CE-4839-8AB5-1BD5590FC888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S1 showed the prevalence of HBP(%) according to age groups in Chinese 6-17 years old children, before and after adjusted for BMI and age. HBP(systolic high blood pressure). **The original prevalence of HBP subtype is significantly different between boys and girls (≤0.001). *The original prevalence of HBP subtype is significantly different between boys and girls (≤0.05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90365B-888E-491F-8FFA-9AE14577B676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C5B0A-1DA1-42A9-8A28-2456FEDF32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4EC5B-F92D-41E6-B1D2-BCF3AD4ACD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40BDC-1C8D-4135-9D65-FAF09C2598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2190F8-2A0E-45CB-AF88-055736611A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20C03-D6C6-4028-8901-ED1FA3CE21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62299-C73D-4CA7-A88E-EDC1180E15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3D2DE-AD60-42A6-B94F-307BDE8069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393DC-278E-4EC0-8E37-A9A09E4A37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B21E9-D0FA-4A73-BD08-A03AE163CA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50E94-105A-4189-92C9-A7F361CA75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3017A-A1EF-4F72-A048-6D47FD31C2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3CD86-72D0-4838-BAB6-2D2E5303D9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29B56B-2F02-41DD-ABE0-25AF127B61D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表 18" descr=""/>
          <p:cNvPicPr/>
          <p:nvPr/>
        </p:nvPicPr>
        <p:blipFill>
          <a:blip r:embed="rId1"/>
          <a:stretch/>
        </p:blipFill>
        <p:spPr>
          <a:xfrm>
            <a:off x="4181400" y="762120"/>
            <a:ext cx="4608720" cy="2090520"/>
          </a:xfrm>
          <a:prstGeom prst="rect">
            <a:avLst/>
          </a:prstGeom>
          <a:ln w="0">
            <a:noFill/>
          </a:ln>
        </p:spPr>
      </p:pic>
      <p:sp>
        <p:nvSpPr>
          <p:cNvPr id="49" name="TextBox 11"/>
          <p:cNvSpPr/>
          <p:nvPr/>
        </p:nvSpPr>
        <p:spPr>
          <a:xfrm>
            <a:off x="5281560" y="210492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6.0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2"/>
          <a:stretch/>
        </p:blipFill>
        <p:spPr>
          <a:xfrm>
            <a:off x="4040280" y="763560"/>
            <a:ext cx="3657600" cy="2098800"/>
          </a:xfrm>
          <a:prstGeom prst="rect">
            <a:avLst/>
          </a:prstGeom>
          <a:ln w="0">
            <a:noFill/>
          </a:ln>
        </p:spPr>
      </p:pic>
      <p:sp>
        <p:nvSpPr>
          <p:cNvPr id="51" name="TextBox 14"/>
          <p:cNvSpPr/>
          <p:nvPr/>
        </p:nvSpPr>
        <p:spPr>
          <a:xfrm rot="10800000">
            <a:off x="133200" y="-531720"/>
            <a:ext cx="362880" cy="424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revalence of different  HBP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3"/>
          <a:stretch/>
        </p:blipFill>
        <p:spPr>
          <a:xfrm>
            <a:off x="1076400" y="-31680"/>
            <a:ext cx="101520" cy="1966680"/>
          </a:xfrm>
          <a:prstGeom prst="rect">
            <a:avLst/>
          </a:prstGeom>
          <a:ln w="0">
            <a:noFill/>
          </a:ln>
        </p:spPr>
      </p:pic>
      <p:sp>
        <p:nvSpPr>
          <p:cNvPr id="53" name="矩形 1"/>
          <p:cNvSpPr/>
          <p:nvPr/>
        </p:nvSpPr>
        <p:spPr>
          <a:xfrm>
            <a:off x="1510200" y="3301920"/>
            <a:ext cx="592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Prevalence of high blood pressure before and after adjusted for BMI and ag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图表 16" descr=""/>
          <p:cNvPicPr/>
          <p:nvPr/>
        </p:nvPicPr>
        <p:blipFill>
          <a:blip r:embed="rId4"/>
          <a:stretch/>
        </p:blipFill>
        <p:spPr>
          <a:xfrm>
            <a:off x="396720" y="639720"/>
            <a:ext cx="4602240" cy="2670120"/>
          </a:xfrm>
          <a:prstGeom prst="rect">
            <a:avLst/>
          </a:prstGeom>
          <a:ln w="0">
            <a:noFill/>
          </a:ln>
        </p:spPr>
      </p:pic>
      <p:pic>
        <p:nvPicPr>
          <p:cNvPr id="55" name="图表 17" descr=""/>
          <p:cNvPicPr/>
          <p:nvPr/>
        </p:nvPicPr>
        <p:blipFill>
          <a:blip r:embed="rId5"/>
          <a:stretch/>
        </p:blipFill>
        <p:spPr>
          <a:xfrm>
            <a:off x="4065480" y="603360"/>
            <a:ext cx="4602240" cy="2663640"/>
          </a:xfrm>
          <a:prstGeom prst="rect">
            <a:avLst/>
          </a:prstGeom>
          <a:ln w="0">
            <a:noFill/>
          </a:ln>
        </p:spPr>
      </p:pic>
      <p:sp>
        <p:nvSpPr>
          <p:cNvPr id="56" name="矩形 1"/>
          <p:cNvSpPr/>
          <p:nvPr/>
        </p:nvSpPr>
        <p:spPr>
          <a:xfrm>
            <a:off x="503280" y="3716280"/>
            <a:ext cx="7597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S1 showed the prevalence of HBP(%) according to age groups in Chinese 6-17 years old children, before and after adjusted for BMI and age. HBP(high blood pressure). **The original prevalence of HBP subtype is significantly different between boys and girls (≤0.001). *The original prevalence of HBP subtype is significantly different between boys and girls (≤0.05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09T07:12:38Z</dcterms:created>
  <dc:creator>Windows 用户</dc:creator>
  <dc:description/>
  <dc:language>en-US</dc:language>
  <cp:lastModifiedBy>yide yang</cp:lastModifiedBy>
  <dcterms:modified xsi:type="dcterms:W3CDTF">2017-02-14T13:52:59Z</dcterms:modified>
  <cp:revision>41</cp:revision>
  <dc:subject/>
  <dc:title>PowerPoint 演示文稿</dc:title>
</cp:coreProperties>
</file>